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sldIdLst>
    <p:sldId id="259" r:id="rId5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megowda" initials="HV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34" autoAdjust="0"/>
  </p:normalViewPr>
  <p:slideViewPr>
    <p:cSldViewPr snapToGrid="0">
      <p:cViewPr>
        <p:scale>
          <a:sx n="75" d="100"/>
          <a:sy n="75" d="100"/>
        </p:scale>
        <p:origin x="516" y="-3846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532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178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120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388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67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223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483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016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498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252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346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405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05542" y="13367656"/>
            <a:ext cx="10755086" cy="11661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7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tabolism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verview map showing differences in transcript levels of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mbine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at and virus infected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. thaliana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lants.  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figure is generated using MapMan softwa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is bas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n 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vided by Prasch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onnewal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2013)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ant Physi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162(4),1849-66. The data (fold change expression values) were loaded into the MapMan Image Annotator modul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rate the metabolism overview map. On the logarithmic color scale ranging from 4.5 to -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.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ee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p-regula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own-regulated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/>
          <a:srcRect r="24456"/>
          <a:stretch/>
        </p:blipFill>
        <p:spPr>
          <a:xfrm>
            <a:off x="805542" y="4056617"/>
            <a:ext cx="11017703" cy="81427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7064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7.PPTX</TitleName>
    <StageName xmlns="ad5e6ac6-7e28-44ff-b599-4b096ee3745e" xsi:nil="true"/>
    <DocumentType xmlns="ad5e6ac6-7e28-44ff-b599-4b096ee3745e">Presentation</DocumentType>
    <DocumentId xmlns="ad5e6ac6-7e28-44ff-b599-4b096ee3745e">Presentation 7.PPTX</DocumentId>
  </documentManagement>
</p:properties>
</file>

<file path=customXml/itemProps1.xml><?xml version="1.0" encoding="utf-8"?>
<ds:datastoreItem xmlns:ds="http://schemas.openxmlformats.org/officeDocument/2006/customXml" ds:itemID="{50E5FC32-95D0-4AB8-87BE-610DBE95168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d5e6ac6-7e28-44ff-b599-4b096ee3745e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3B2DE73A-BE86-4AA6-BFBE-8C02A554F09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AC54BBB-54E4-4684-B11C-26E63BA97D30}">
  <ds:schemaRefs>
    <ds:schemaRef ds:uri="http://schemas.openxmlformats.org/package/2006/metadata/core-properties"/>
    <ds:schemaRef ds:uri="http://schemas.microsoft.com/office/2006/documentManagement/types"/>
    <ds:schemaRef ds:uri="http://purl.org/dc/terms/"/>
    <ds:schemaRef ds:uri="http://purl.org/dc/elements/1.1/"/>
    <ds:schemaRef ds:uri="http://www.w3.org/XML/1998/namespace"/>
    <ds:schemaRef ds:uri="http://purl.org/dc/dcmitype/"/>
    <ds:schemaRef ds:uri="http://schemas.microsoft.com/office/2006/metadata/properties"/>
    <ds:schemaRef ds:uri="ad5e6ac6-7e28-44ff-b599-4b096ee3745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0</TotalTime>
  <Words>2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enthil-Kumar Muthappa</cp:lastModifiedBy>
  <cp:revision>44</cp:revision>
  <dcterms:created xsi:type="dcterms:W3CDTF">2015-06-03T08:23:24Z</dcterms:created>
  <dcterms:modified xsi:type="dcterms:W3CDTF">2015-08-04T11:26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